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0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942"/>
    <p:restoredTop sz="94621"/>
  </p:normalViewPr>
  <p:slideViewPr>
    <p:cSldViewPr snapToGrid="0" snapToObjects="1" showGuides="1">
      <p:cViewPr varScale="1">
        <p:scale>
          <a:sx n="114" d="100"/>
          <a:sy n="114" d="100"/>
        </p:scale>
        <p:origin x="132" y="126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74475B-40AC-834D-AD11-28195F249B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76E01BA-8D18-8343-BE50-5FF08BA708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5BB18F-B1C5-E849-9510-35CD198B3C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0FD6-DD39-B044-BCE7-75B867703231}" type="datetimeFigureOut">
              <a:rPr lang="en-US" smtClean="0"/>
              <a:t>14/0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1AD807-6627-8644-9426-860A383271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25E8BD-5C0A-B24C-AF98-662D17CB3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F966-8D53-B846-87FF-9131011B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397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3DFDD8-00A5-C54A-B655-142002E808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C8504F-6A79-2642-B9CB-5CD3EFA248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4611AB-9D48-334D-8069-FC8271858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0FD6-DD39-B044-BCE7-75B867703231}" type="datetimeFigureOut">
              <a:rPr lang="en-US" smtClean="0"/>
              <a:t>14/0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3F30C5-EF64-F647-B48D-E27341B5F2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E04DDE-6C44-6945-B47D-E90E3F936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F966-8D53-B846-87FF-9131011B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96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AEC4316-E990-E644-8E45-3972282292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0AD881-DE67-B647-9D97-01AA11995D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C1D776-5C85-3746-9E8A-5B714904BE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0FD6-DD39-B044-BCE7-75B867703231}" type="datetimeFigureOut">
              <a:rPr lang="en-US" smtClean="0"/>
              <a:t>14/0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166C9F-6CF8-9A41-8422-7D297F25CC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E3CAF0-7DF3-F34A-90E2-232AD1CE37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F966-8D53-B846-87FF-9131011B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534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98290B-C549-8E4F-BE4E-58DB5CDEBF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EFB618-DAEB-DA4A-9794-A68A7B5F09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184D76-2AF8-F547-8A9C-D45DF3DF8F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0FD6-DD39-B044-BCE7-75B867703231}" type="datetimeFigureOut">
              <a:rPr lang="en-US" smtClean="0"/>
              <a:t>14/0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DA3087-193B-B544-95C9-C8E6B009A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5FC2BB-25D5-8744-994B-CBF07462A8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F966-8D53-B846-87FF-9131011B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103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C18F7A-3164-C542-BEFE-14A8094A16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8B81DF-5C14-474F-82DA-4C4FBBD8C8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F59943-6439-CC46-A302-75246FACFB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0FD6-DD39-B044-BCE7-75B867703231}" type="datetimeFigureOut">
              <a:rPr lang="en-US" smtClean="0"/>
              <a:t>14/0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EB37BE-15D3-6940-A959-B6587FBAE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A71281-ADAB-B247-8F2E-C2469EB264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F966-8D53-B846-87FF-9131011B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92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7A2A96-77E6-7046-BE80-EE03185AE3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10BFAC-89E6-AA49-9096-C13BA9F06C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03D69D-0A8A-224A-88A6-BA1B1772C8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6DB09B-3E56-3B44-A506-9BAE0B69B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0FD6-DD39-B044-BCE7-75B867703231}" type="datetimeFigureOut">
              <a:rPr lang="en-US" smtClean="0"/>
              <a:t>14/0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1A4E5D-1B11-F64A-AD6E-5741B3736F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1FC61F-C7FF-664B-9AFB-C567889D5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F966-8D53-B846-87FF-9131011B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541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24AC18-DEB7-E246-804D-023E574DB8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F67BBD-486F-2547-AA2D-5C1FF49A4A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F00333-9748-9549-BAB0-FFDD7FDDB6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78275FF-ADC6-3A4B-9D91-4A5C11D3B8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8DD9588-740C-AD41-AB9F-24F1934727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35D2397-970C-4F43-A2EC-4587B8F199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0FD6-DD39-B044-BCE7-75B867703231}" type="datetimeFigureOut">
              <a:rPr lang="en-US" smtClean="0"/>
              <a:t>14/09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CE7B6C-A4FE-D148-A70D-70FC303445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247734D-467B-BC47-86E5-63F589158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F966-8D53-B846-87FF-9131011B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3017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EE2623-C567-104A-A88F-B1DE157414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35A7901-7335-A046-BCD1-39F148133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0FD6-DD39-B044-BCE7-75B867703231}" type="datetimeFigureOut">
              <a:rPr lang="en-US" smtClean="0"/>
              <a:t>14/09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2E7640B-44E9-E64E-8E70-10D3B252F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99011D7-AE40-0746-99D0-FC49876925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F966-8D53-B846-87FF-9131011B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137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39CDDBF-10C8-F541-86D1-3CF2FBEABE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0FD6-DD39-B044-BCE7-75B867703231}" type="datetimeFigureOut">
              <a:rPr lang="en-US" smtClean="0"/>
              <a:t>14/09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74129CE-B655-EE43-849E-306F31DBE3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336BE6-15BD-274E-9CD7-FB97EA7AE3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F966-8D53-B846-87FF-9131011B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315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3456FB-9BBD-1449-9E78-829980D24D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C6242A-0787-AD4D-9664-0BE41153C5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00266BF-D013-5F4D-BD22-0442697917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6B2719-55AD-D247-828C-92356A5A54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0FD6-DD39-B044-BCE7-75B867703231}" type="datetimeFigureOut">
              <a:rPr lang="en-US" smtClean="0"/>
              <a:t>14/0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50C771-45C8-7147-92FA-847740C327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410E11-410D-8B4E-8A72-AB5402F7D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F966-8D53-B846-87FF-9131011B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965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CC051D-1471-9A43-847F-0E77186FEF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856E82-F076-AD47-B68F-E76524D852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97C711-1D8D-1044-85DF-C41CE07A17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277740-BD39-3648-ADA6-5230EEBEE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60FD6-DD39-B044-BCE7-75B867703231}" type="datetimeFigureOut">
              <a:rPr lang="en-US" smtClean="0"/>
              <a:t>14/0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6021D0-A2F0-EE41-B6F7-0023926410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EA462C-D020-3840-8805-66D66A7F55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EF966-8D53-B846-87FF-9131011B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6954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DAB9495-1CCF-534B-B1CA-ABFE2673B2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1A62FE-521D-6547-8FF2-A498E56CE7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AC2ED8-3CAE-9E42-BE6B-8D946814A9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60FD6-DD39-B044-BCE7-75B867703231}" type="datetimeFigureOut">
              <a:rPr lang="en-US" smtClean="0"/>
              <a:t>14/0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710910-AACF-3F4A-BF3E-232FDCA305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1B08F9-81D2-004C-9981-7B0FE3043E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1EF966-8D53-B846-87FF-9131011BA0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512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5.png"/><Relationship Id="rId7" Type="http://schemas.openxmlformats.org/officeDocument/2006/relationships/image" Target="../media/image9.em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emf"/><Relationship Id="rId5" Type="http://schemas.openxmlformats.org/officeDocument/2006/relationships/image" Target="../media/image7.png"/><Relationship Id="rId4" Type="http://schemas.openxmlformats.org/officeDocument/2006/relationships/image" Target="../media/image6.png"/><Relationship Id="rId9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jp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5" Type="http://schemas.openxmlformats.org/officeDocument/2006/relationships/image" Target="../media/image15.png"/><Relationship Id="rId4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FC597D7A-1EC4-0B40-8DB2-5BE158833D16}"/>
              </a:ext>
            </a:extLst>
          </p:cNvPr>
          <p:cNvSpPr txBox="1"/>
          <p:nvPr/>
        </p:nvSpPr>
        <p:spPr>
          <a:xfrm>
            <a:off x="5622415" y="107081"/>
            <a:ext cx="3396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E1173F8C-7D9A-D74C-9552-915A8C7C907F}"/>
              </a:ext>
            </a:extLst>
          </p:cNvPr>
          <p:cNvGrpSpPr/>
          <p:nvPr/>
        </p:nvGrpSpPr>
        <p:grpSpPr>
          <a:xfrm>
            <a:off x="1452143" y="0"/>
            <a:ext cx="3429000" cy="6858000"/>
            <a:chOff x="908130" y="0"/>
            <a:chExt cx="3429000" cy="6858000"/>
          </a:xfrm>
        </p:grpSpPr>
        <p:pic>
          <p:nvPicPr>
            <p:cNvPr id="21" name="Picture 20" descr="A close up of a logo&#10;&#10;Description automatically generated">
              <a:extLst>
                <a:ext uri="{FF2B5EF4-FFF2-40B4-BE49-F238E27FC236}">
                  <a16:creationId xmlns:a16="http://schemas.microsoft.com/office/drawing/2014/main" id="{7A82BD9D-1BAF-134B-94F7-DF02A5C2403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08130" y="0"/>
              <a:ext cx="3429000" cy="6858000"/>
            </a:xfrm>
            <a:prstGeom prst="rect">
              <a:avLst/>
            </a:prstGeom>
          </p:spPr>
        </p:pic>
        <p:sp>
          <p:nvSpPr>
            <p:cNvPr id="22" name="Rounded Rectangle 21">
              <a:extLst>
                <a:ext uri="{FF2B5EF4-FFF2-40B4-BE49-F238E27FC236}">
                  <a16:creationId xmlns:a16="http://schemas.microsoft.com/office/drawing/2014/main" id="{A81C18F8-537F-CF4F-8330-16EF07522D66}"/>
                </a:ext>
              </a:extLst>
            </p:cNvPr>
            <p:cNvSpPr/>
            <p:nvPr/>
          </p:nvSpPr>
          <p:spPr>
            <a:xfrm>
              <a:off x="2942714" y="1337187"/>
              <a:ext cx="335260" cy="1120878"/>
            </a:xfrm>
            <a:prstGeom prst="roundRect">
              <a:avLst/>
            </a:prstGeom>
            <a:noFill/>
            <a:ln w="1905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QA"/>
            </a:p>
          </p:txBody>
        </p:sp>
        <p:sp>
          <p:nvSpPr>
            <p:cNvPr id="23" name="Rounded Rectangle 22">
              <a:extLst>
                <a:ext uri="{FF2B5EF4-FFF2-40B4-BE49-F238E27FC236}">
                  <a16:creationId xmlns:a16="http://schemas.microsoft.com/office/drawing/2014/main" id="{33EBD1E5-0EA1-3E45-B155-118D06A529DD}"/>
                </a:ext>
              </a:extLst>
            </p:cNvPr>
            <p:cNvSpPr/>
            <p:nvPr/>
          </p:nvSpPr>
          <p:spPr>
            <a:xfrm>
              <a:off x="3397550" y="622300"/>
              <a:ext cx="168078" cy="353961"/>
            </a:xfrm>
            <a:prstGeom prst="roundRect">
              <a:avLst/>
            </a:prstGeom>
            <a:noFill/>
            <a:ln w="1905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QA"/>
            </a:p>
          </p:txBody>
        </p:sp>
        <p:sp>
          <p:nvSpPr>
            <p:cNvPr id="24" name="Rounded Rectangle 23">
              <a:extLst>
                <a:ext uri="{FF2B5EF4-FFF2-40B4-BE49-F238E27FC236}">
                  <a16:creationId xmlns:a16="http://schemas.microsoft.com/office/drawing/2014/main" id="{F89A72E4-4BDC-3F43-996D-DD7534DE99E0}"/>
                </a:ext>
              </a:extLst>
            </p:cNvPr>
            <p:cNvSpPr/>
            <p:nvPr/>
          </p:nvSpPr>
          <p:spPr>
            <a:xfrm>
              <a:off x="3141407" y="5839337"/>
              <a:ext cx="256144" cy="396363"/>
            </a:xfrm>
            <a:prstGeom prst="roundRect">
              <a:avLst/>
            </a:prstGeom>
            <a:noFill/>
            <a:ln w="1905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QA"/>
            </a:p>
          </p:txBody>
        </p:sp>
        <p:sp>
          <p:nvSpPr>
            <p:cNvPr id="25" name="Rounded Rectangle 24">
              <a:extLst>
                <a:ext uri="{FF2B5EF4-FFF2-40B4-BE49-F238E27FC236}">
                  <a16:creationId xmlns:a16="http://schemas.microsoft.com/office/drawing/2014/main" id="{C4D50B26-1661-BE49-AEFD-09F5326042E6}"/>
                </a:ext>
              </a:extLst>
            </p:cNvPr>
            <p:cNvSpPr/>
            <p:nvPr/>
          </p:nvSpPr>
          <p:spPr>
            <a:xfrm>
              <a:off x="2930013" y="3257550"/>
              <a:ext cx="256144" cy="488950"/>
            </a:xfrm>
            <a:prstGeom prst="roundRect">
              <a:avLst/>
            </a:prstGeom>
            <a:noFill/>
            <a:ln w="1905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QA"/>
            </a:p>
          </p:txBody>
        </p:sp>
        <p:sp>
          <p:nvSpPr>
            <p:cNvPr id="26" name="Rounded Rectangle 25">
              <a:extLst>
                <a:ext uri="{FF2B5EF4-FFF2-40B4-BE49-F238E27FC236}">
                  <a16:creationId xmlns:a16="http://schemas.microsoft.com/office/drawing/2014/main" id="{8319AB01-F7FE-144A-9310-1207DF7766A1}"/>
                </a:ext>
              </a:extLst>
            </p:cNvPr>
            <p:cNvSpPr/>
            <p:nvPr/>
          </p:nvSpPr>
          <p:spPr>
            <a:xfrm>
              <a:off x="3265273" y="1140542"/>
              <a:ext cx="168078" cy="196646"/>
            </a:xfrm>
            <a:prstGeom prst="roundRect">
              <a:avLst/>
            </a:prstGeom>
            <a:noFill/>
            <a:ln w="1905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QA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F05B14F-FCEA-0D49-BACC-76C9FEF6BD8E}"/>
                </a:ext>
              </a:extLst>
            </p:cNvPr>
            <p:cNvSpPr txBox="1"/>
            <p:nvPr/>
          </p:nvSpPr>
          <p:spPr>
            <a:xfrm>
              <a:off x="3545210" y="665987"/>
              <a:ext cx="61106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QA" sz="1100" b="1" dirty="0"/>
                <a:t>ST1193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11DDD4A-341D-B94A-8554-48729CB30EEF}"/>
                </a:ext>
              </a:extLst>
            </p:cNvPr>
            <p:cNvSpPr txBox="1"/>
            <p:nvPr/>
          </p:nvSpPr>
          <p:spPr>
            <a:xfrm>
              <a:off x="3396099" y="1108060"/>
              <a:ext cx="4667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QA" sz="1100" b="1" dirty="0"/>
                <a:t>ST73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110FDA0-9E69-9740-8EBC-FEB7048DAD1F}"/>
                </a:ext>
              </a:extLst>
            </p:cNvPr>
            <p:cNvSpPr txBox="1"/>
            <p:nvPr/>
          </p:nvSpPr>
          <p:spPr>
            <a:xfrm>
              <a:off x="3339488" y="1716987"/>
              <a:ext cx="5389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QA" sz="1100" b="1" dirty="0"/>
                <a:t>ST131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5F82D9F-2B85-AE4F-A3D8-11C1425C1B5A}"/>
                </a:ext>
              </a:extLst>
            </p:cNvPr>
            <p:cNvSpPr txBox="1"/>
            <p:nvPr/>
          </p:nvSpPr>
          <p:spPr>
            <a:xfrm>
              <a:off x="3202444" y="3371220"/>
              <a:ext cx="4667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QA" sz="1100" b="1" dirty="0"/>
                <a:t>ST38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60FADB5-49A5-2B4C-BA81-31BF6734C174}"/>
                </a:ext>
              </a:extLst>
            </p:cNvPr>
            <p:cNvSpPr txBox="1"/>
            <p:nvPr/>
          </p:nvSpPr>
          <p:spPr>
            <a:xfrm>
              <a:off x="3365387" y="5906713"/>
              <a:ext cx="4667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QA" sz="1100" b="1" dirty="0"/>
                <a:t>ST10</a:t>
              </a:r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06C77219-9B84-1F4B-AE8D-025A5D75A18E}"/>
              </a:ext>
            </a:extLst>
          </p:cNvPr>
          <p:cNvSpPr txBox="1"/>
          <p:nvPr/>
        </p:nvSpPr>
        <p:spPr>
          <a:xfrm>
            <a:off x="137662" y="107081"/>
            <a:ext cx="1413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1</a:t>
            </a:r>
          </a:p>
        </p:txBody>
      </p:sp>
    </p:spTree>
    <p:extLst>
      <p:ext uri="{BB962C8B-B14F-4D97-AF65-F5344CB8AC3E}">
        <p14:creationId xmlns:p14="http://schemas.microsoft.com/office/powerpoint/2010/main" val="32470188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0ED20180-258D-2E4F-9537-E0465C631204}"/>
              </a:ext>
            </a:extLst>
          </p:cNvPr>
          <p:cNvGrpSpPr/>
          <p:nvPr/>
        </p:nvGrpSpPr>
        <p:grpSpPr>
          <a:xfrm>
            <a:off x="620446" y="107966"/>
            <a:ext cx="11069711" cy="6536999"/>
            <a:chOff x="620446" y="107966"/>
            <a:chExt cx="11069711" cy="6536999"/>
          </a:xfrm>
        </p:grpSpPr>
        <p:pic>
          <p:nvPicPr>
            <p:cNvPr id="12" name="Picture 11" descr="A close up of a device&#10;&#10;Description automatically generated">
              <a:extLst>
                <a:ext uri="{FF2B5EF4-FFF2-40B4-BE49-F238E27FC236}">
                  <a16:creationId xmlns:a16="http://schemas.microsoft.com/office/drawing/2014/main" id="{5C5E3695-7674-2343-A9FB-97B6F7EECA0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05256" y="649843"/>
              <a:ext cx="1728216" cy="5995122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4F0222C-0C05-AF40-8710-DB19217E995C}"/>
                </a:ext>
              </a:extLst>
            </p:cNvPr>
            <p:cNvSpPr txBox="1"/>
            <p:nvPr/>
          </p:nvSpPr>
          <p:spPr>
            <a:xfrm>
              <a:off x="620446" y="239554"/>
              <a:ext cx="16205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/>
                <a:t>E. coli </a:t>
              </a:r>
              <a:r>
                <a:rPr lang="en-US" sz="1400" b="1" dirty="0"/>
                <a:t>– ST131</a:t>
              </a:r>
            </a:p>
          </p:txBody>
        </p:sp>
        <p:sp>
          <p:nvSpPr>
            <p:cNvPr id="5" name="Right Bracket 4">
              <a:extLst>
                <a:ext uri="{FF2B5EF4-FFF2-40B4-BE49-F238E27FC236}">
                  <a16:creationId xmlns:a16="http://schemas.microsoft.com/office/drawing/2014/main" id="{9A6248B7-7CDE-C444-909C-3924E2D0B37D}"/>
                </a:ext>
              </a:extLst>
            </p:cNvPr>
            <p:cNvSpPr/>
            <p:nvPr/>
          </p:nvSpPr>
          <p:spPr>
            <a:xfrm>
              <a:off x="10536129" y="645315"/>
              <a:ext cx="253828" cy="2792892"/>
            </a:xfrm>
            <a:prstGeom prst="rightBracket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QA"/>
            </a:p>
          </p:txBody>
        </p:sp>
        <p:sp>
          <p:nvSpPr>
            <p:cNvPr id="6" name="Right Bracket 5">
              <a:extLst>
                <a:ext uri="{FF2B5EF4-FFF2-40B4-BE49-F238E27FC236}">
                  <a16:creationId xmlns:a16="http://schemas.microsoft.com/office/drawing/2014/main" id="{F5334C0E-4E30-634A-AB80-FF94A6A9CC5F}"/>
                </a:ext>
              </a:extLst>
            </p:cNvPr>
            <p:cNvSpPr/>
            <p:nvPr/>
          </p:nvSpPr>
          <p:spPr>
            <a:xfrm>
              <a:off x="10536129" y="3442943"/>
              <a:ext cx="253828" cy="3177314"/>
            </a:xfrm>
            <a:prstGeom prst="rightBracket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QA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9F2D7F9-214D-A04B-A537-1D890052200B}"/>
                </a:ext>
              </a:extLst>
            </p:cNvPr>
            <p:cNvSpPr txBox="1"/>
            <p:nvPr/>
          </p:nvSpPr>
          <p:spPr>
            <a:xfrm>
              <a:off x="10883522" y="1448223"/>
              <a:ext cx="3396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I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1561E8A-6629-1449-9384-1A3294285947}"/>
                </a:ext>
              </a:extLst>
            </p:cNvPr>
            <p:cNvSpPr txBox="1"/>
            <p:nvPr/>
          </p:nvSpPr>
          <p:spPr>
            <a:xfrm>
              <a:off x="10884837" y="4584077"/>
              <a:ext cx="3396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II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6E3649A-E81D-654A-88E6-943199AA1FFA}"/>
                </a:ext>
              </a:extLst>
            </p:cNvPr>
            <p:cNvSpPr txBox="1"/>
            <p:nvPr/>
          </p:nvSpPr>
          <p:spPr>
            <a:xfrm>
              <a:off x="11350497" y="107966"/>
              <a:ext cx="3396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44F1D985-BF56-C14F-8630-FB3E63C9541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52292" y="239554"/>
              <a:ext cx="7876612" cy="638070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675775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>
            <a:extLst>
              <a:ext uri="{FF2B5EF4-FFF2-40B4-BE49-F238E27FC236}">
                <a16:creationId xmlns:a16="http://schemas.microsoft.com/office/drawing/2014/main" id="{FBD1D26A-82DB-F744-AC14-32A2B1532187}"/>
              </a:ext>
            </a:extLst>
          </p:cNvPr>
          <p:cNvGrpSpPr/>
          <p:nvPr/>
        </p:nvGrpSpPr>
        <p:grpSpPr>
          <a:xfrm>
            <a:off x="168067" y="29159"/>
            <a:ext cx="11754099" cy="6723169"/>
            <a:chOff x="168067" y="29159"/>
            <a:chExt cx="11754099" cy="6723169"/>
          </a:xfrm>
        </p:grpSpPr>
        <p:pic>
          <p:nvPicPr>
            <p:cNvPr id="22" name="Picture 21" descr="A close up of a logo&#10;&#10;Description automatically generated">
              <a:extLst>
                <a:ext uri="{FF2B5EF4-FFF2-40B4-BE49-F238E27FC236}">
                  <a16:creationId xmlns:a16="http://schemas.microsoft.com/office/drawing/2014/main" id="{282DE85B-8077-984E-B39B-302ACAEB985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9834" y="561325"/>
              <a:ext cx="1343565" cy="2815769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E1323DF-8F15-D04C-84C6-E231692686EC}"/>
                </a:ext>
              </a:extLst>
            </p:cNvPr>
            <p:cNvSpPr txBox="1"/>
            <p:nvPr/>
          </p:nvSpPr>
          <p:spPr>
            <a:xfrm>
              <a:off x="11547143" y="323410"/>
              <a:ext cx="3396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5BE5F17-4AD1-6B4D-9FC8-89598BB820F9}"/>
                </a:ext>
              </a:extLst>
            </p:cNvPr>
            <p:cNvSpPr txBox="1"/>
            <p:nvPr/>
          </p:nvSpPr>
          <p:spPr>
            <a:xfrm>
              <a:off x="6962391" y="1202357"/>
              <a:ext cx="11062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i="1" dirty="0"/>
                <a:t>E. coli </a:t>
              </a:r>
              <a:r>
                <a:rPr lang="en-US" sz="1400" b="1" dirty="0"/>
                <a:t>- ST73</a:t>
              </a:r>
            </a:p>
          </p:txBody>
        </p:sp>
        <p:pic>
          <p:nvPicPr>
            <p:cNvPr id="6" name="Picture 5" descr="A picture containing object, clock&#10;&#10;Description automatically generated">
              <a:extLst>
                <a:ext uri="{FF2B5EF4-FFF2-40B4-BE49-F238E27FC236}">
                  <a16:creationId xmlns:a16="http://schemas.microsoft.com/office/drawing/2014/main" id="{1E33F903-573C-B342-BF5C-E9E7E397F6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917" r="36007"/>
            <a:stretch/>
          </p:blipFill>
          <p:spPr>
            <a:xfrm>
              <a:off x="6933672" y="1618689"/>
              <a:ext cx="1399241" cy="1472876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AC9F77A-E30B-534F-979D-B363C592FDEA}"/>
                </a:ext>
              </a:extLst>
            </p:cNvPr>
            <p:cNvSpPr txBox="1"/>
            <p:nvPr/>
          </p:nvSpPr>
          <p:spPr>
            <a:xfrm>
              <a:off x="6584349" y="3791266"/>
              <a:ext cx="12889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i="1" dirty="0"/>
                <a:t>E. coli </a:t>
              </a:r>
              <a:r>
                <a:rPr lang="en-US" sz="1400" b="1" dirty="0"/>
                <a:t>- ST1193</a:t>
              </a:r>
            </a:p>
          </p:txBody>
        </p:sp>
        <p:pic>
          <p:nvPicPr>
            <p:cNvPr id="12" name="Picture 11" descr="A close up of a device&#10;&#10;Description automatically generated">
              <a:extLst>
                <a:ext uri="{FF2B5EF4-FFF2-40B4-BE49-F238E27FC236}">
                  <a16:creationId xmlns:a16="http://schemas.microsoft.com/office/drawing/2014/main" id="{D86E5BCE-8C20-724D-9028-C502B97932F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833054" y="4687551"/>
              <a:ext cx="791535" cy="1557674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A65F4A4-0627-294B-B551-91D82D4CA200}"/>
                </a:ext>
              </a:extLst>
            </p:cNvPr>
            <p:cNvSpPr txBox="1"/>
            <p:nvPr/>
          </p:nvSpPr>
          <p:spPr>
            <a:xfrm>
              <a:off x="168067" y="29159"/>
              <a:ext cx="16205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/>
                <a:t>E. coli </a:t>
              </a:r>
              <a:r>
                <a:rPr lang="en-US" sz="1400" b="1" dirty="0"/>
                <a:t>- ST38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3FC6084-703C-F943-B01E-61D591C2E4C5}"/>
                </a:ext>
              </a:extLst>
            </p:cNvPr>
            <p:cNvSpPr txBox="1"/>
            <p:nvPr/>
          </p:nvSpPr>
          <p:spPr>
            <a:xfrm>
              <a:off x="238959" y="3563532"/>
              <a:ext cx="14787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i="1" dirty="0"/>
                <a:t>E. coli </a:t>
              </a:r>
              <a:r>
                <a:rPr lang="en-US" sz="1400" b="1" dirty="0"/>
                <a:t>- ST10</a:t>
              </a:r>
            </a:p>
          </p:txBody>
        </p:sp>
        <p:pic>
          <p:nvPicPr>
            <p:cNvPr id="19" name="Picture 18" descr="A picture containing object, clock&#10;&#10;Description automatically generated">
              <a:extLst>
                <a:ext uri="{FF2B5EF4-FFF2-40B4-BE49-F238E27FC236}">
                  <a16:creationId xmlns:a16="http://schemas.microsoft.com/office/drawing/2014/main" id="{765EB43D-AB3B-B942-A967-FA649E77447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12963" y="4086843"/>
              <a:ext cx="724376" cy="2619828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1109EC7D-3E98-5441-ABAA-2448F5E625F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528165" y="128822"/>
              <a:ext cx="4883919" cy="3216446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1E1FCFEF-5F16-ED47-8D49-9096DC599C3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702708" y="4289526"/>
              <a:ext cx="4120875" cy="1932549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7A918D81-BE7F-DC44-94E6-CCE220F7955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8286985" y="1205084"/>
              <a:ext cx="3635181" cy="1828606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AAC544D7-AB14-AA4F-920E-20995CB81CF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870416" y="3674105"/>
              <a:ext cx="3086680" cy="307822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864088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" name="Group 62">
            <a:extLst>
              <a:ext uri="{FF2B5EF4-FFF2-40B4-BE49-F238E27FC236}">
                <a16:creationId xmlns:a16="http://schemas.microsoft.com/office/drawing/2014/main" id="{5CAFE312-9B23-7A48-8575-7D198578F11B}"/>
              </a:ext>
            </a:extLst>
          </p:cNvPr>
          <p:cNvGrpSpPr/>
          <p:nvPr/>
        </p:nvGrpSpPr>
        <p:grpSpPr>
          <a:xfrm>
            <a:off x="264985" y="121389"/>
            <a:ext cx="11823840" cy="6497087"/>
            <a:chOff x="264985" y="121389"/>
            <a:chExt cx="11823840" cy="6497087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E066DF9-C009-2545-BAD8-77A57DE72347}"/>
                </a:ext>
              </a:extLst>
            </p:cNvPr>
            <p:cNvSpPr txBox="1"/>
            <p:nvPr/>
          </p:nvSpPr>
          <p:spPr>
            <a:xfrm>
              <a:off x="11749165" y="121389"/>
              <a:ext cx="3396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D9B261E0-4420-6844-9F14-B00C7759DE3E}"/>
                </a:ext>
              </a:extLst>
            </p:cNvPr>
            <p:cNvGrpSpPr/>
            <p:nvPr/>
          </p:nvGrpSpPr>
          <p:grpSpPr>
            <a:xfrm>
              <a:off x="4042645" y="4908520"/>
              <a:ext cx="7745937" cy="1709956"/>
              <a:chOff x="4034065" y="2953189"/>
              <a:chExt cx="7745937" cy="1709956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A62AB1BF-9FC4-E243-B15B-1F6594849E4D}"/>
                  </a:ext>
                </a:extLst>
              </p:cNvPr>
              <p:cNvSpPr txBox="1"/>
              <p:nvPr/>
            </p:nvSpPr>
            <p:spPr>
              <a:xfrm>
                <a:off x="4034065" y="2978565"/>
                <a:ext cx="188372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i="1" dirty="0"/>
                  <a:t>K. pneumoniae </a:t>
                </a:r>
                <a:r>
                  <a:rPr lang="en-US" sz="1400" b="1" dirty="0"/>
                  <a:t>- ST268</a:t>
                </a:r>
              </a:p>
            </p:txBody>
          </p:sp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0E8250B7-68FC-A941-BD55-11424DB2F97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433302" y="2953189"/>
                <a:ext cx="5346700" cy="1574800"/>
              </a:xfrm>
              <a:prstGeom prst="rect">
                <a:avLst/>
              </a:prstGeom>
            </p:spPr>
          </p:pic>
          <p:pic>
            <p:nvPicPr>
              <p:cNvPr id="6" name="Picture 5" descr="A close up of a logo&#10;&#10;Description automatically generated">
                <a:extLst>
                  <a:ext uri="{FF2B5EF4-FFF2-40B4-BE49-F238E27FC236}">
                    <a16:creationId xmlns:a16="http://schemas.microsoft.com/office/drawing/2014/main" id="{60EBD640-9AA9-2148-8CF7-79E0834A8FD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312708" y="3533334"/>
                <a:ext cx="2060660" cy="1129811"/>
              </a:xfrm>
              <a:prstGeom prst="rect">
                <a:avLst/>
              </a:prstGeom>
            </p:spPr>
          </p:pic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7E0677F1-57BE-1D4B-A9D8-C039B98ACEA6}"/>
                </a:ext>
              </a:extLst>
            </p:cNvPr>
            <p:cNvGrpSpPr/>
            <p:nvPr/>
          </p:nvGrpSpPr>
          <p:grpSpPr>
            <a:xfrm>
              <a:off x="4043996" y="501984"/>
              <a:ext cx="7949137" cy="1637306"/>
              <a:chOff x="4034065" y="5029053"/>
              <a:chExt cx="7949137" cy="1637306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9E5DECB-F0AD-4444-9721-52E95EF099A6}"/>
                  </a:ext>
                </a:extLst>
              </p:cNvPr>
              <p:cNvSpPr txBox="1"/>
              <p:nvPr/>
            </p:nvSpPr>
            <p:spPr>
              <a:xfrm>
                <a:off x="4034065" y="5029053"/>
                <a:ext cx="179235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i="1" dirty="0"/>
                  <a:t>K. pneumoniae </a:t>
                </a:r>
                <a:r>
                  <a:rPr lang="en-US" sz="1400" b="1" dirty="0"/>
                  <a:t>- ST45</a:t>
                </a:r>
              </a:p>
            </p:txBody>
          </p:sp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9F9EC44D-4A12-D14A-BDCE-A2C2387FC0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433302" y="5030851"/>
                <a:ext cx="5549900" cy="1536700"/>
              </a:xfrm>
              <a:prstGeom prst="rect">
                <a:avLst/>
              </a:prstGeom>
            </p:spPr>
          </p:pic>
          <p:pic>
            <p:nvPicPr>
              <p:cNvPr id="18" name="Picture 17" descr="A picture containing clock, table&#10;&#10;Description automatically generated">
                <a:extLst>
                  <a:ext uri="{FF2B5EF4-FFF2-40B4-BE49-F238E27FC236}">
                    <a16:creationId xmlns:a16="http://schemas.microsoft.com/office/drawing/2014/main" id="{5B3B8E91-137A-9447-9E0A-10763AB459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044129" y="5289478"/>
                <a:ext cx="2352802" cy="1376881"/>
              </a:xfrm>
              <a:prstGeom prst="rect">
                <a:avLst/>
              </a:prstGeom>
            </p:spPr>
          </p:pic>
        </p:grp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F6A41BBA-5E1D-144B-BBC8-468F9230C013}"/>
                </a:ext>
              </a:extLst>
            </p:cNvPr>
            <p:cNvGrpSpPr/>
            <p:nvPr/>
          </p:nvGrpSpPr>
          <p:grpSpPr>
            <a:xfrm>
              <a:off x="4043996" y="2467384"/>
              <a:ext cx="7301437" cy="2174726"/>
              <a:chOff x="4034065" y="455559"/>
              <a:chExt cx="7301437" cy="2174726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AC8CE6A9-FC28-B84B-A14E-91A6338CDDF9}"/>
                  </a:ext>
                </a:extLst>
              </p:cNvPr>
              <p:cNvSpPr txBox="1"/>
              <p:nvPr/>
            </p:nvSpPr>
            <p:spPr>
              <a:xfrm>
                <a:off x="4034065" y="455559"/>
                <a:ext cx="25433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/>
                  <a:t>K. pneumoniae </a:t>
                </a:r>
                <a:r>
                  <a:rPr lang="en-US" sz="1400" b="1" dirty="0"/>
                  <a:t>- ST307</a:t>
                </a:r>
              </a:p>
            </p:txBody>
          </p:sp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0FECA03A-EB4F-7C4B-94F0-DFF23E76B7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433302" y="491497"/>
                <a:ext cx="4902200" cy="1955800"/>
              </a:xfrm>
              <a:prstGeom prst="rect">
                <a:avLst/>
              </a:prstGeom>
            </p:spPr>
          </p:pic>
          <p:pic>
            <p:nvPicPr>
              <p:cNvPr id="21" name="Picture 20" descr="A close up of a logo&#10;&#10;Description automatically generated">
                <a:extLst>
                  <a:ext uri="{FF2B5EF4-FFF2-40B4-BE49-F238E27FC236}">
                    <a16:creationId xmlns:a16="http://schemas.microsoft.com/office/drawing/2014/main" id="{054FE27B-6346-3E45-AF11-0B8ECCAD505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283312" y="1110028"/>
                <a:ext cx="859276" cy="1520257"/>
              </a:xfrm>
              <a:prstGeom prst="rect">
                <a:avLst/>
              </a:prstGeom>
            </p:spPr>
          </p:pic>
        </p:grpSp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AEACD570-44E9-D04B-A39A-0FF56B3217B3}"/>
                </a:ext>
              </a:extLst>
            </p:cNvPr>
            <p:cNvGrpSpPr/>
            <p:nvPr/>
          </p:nvGrpSpPr>
          <p:grpSpPr>
            <a:xfrm>
              <a:off x="344579" y="792720"/>
              <a:ext cx="3205963" cy="5518295"/>
              <a:chOff x="251979" y="121389"/>
              <a:chExt cx="3205963" cy="5518295"/>
            </a:xfrm>
          </p:grpSpPr>
          <p:sp>
            <p:nvSpPr>
              <p:cNvPr id="41" name="Rounded Rectangle 40">
                <a:extLst>
                  <a:ext uri="{FF2B5EF4-FFF2-40B4-BE49-F238E27FC236}">
                    <a16:creationId xmlns:a16="http://schemas.microsoft.com/office/drawing/2014/main" id="{48D3AA3F-5F04-BD4F-9A38-5D50407AA5AC}"/>
                  </a:ext>
                </a:extLst>
              </p:cNvPr>
              <p:cNvSpPr/>
              <p:nvPr/>
            </p:nvSpPr>
            <p:spPr>
              <a:xfrm>
                <a:off x="2498651" y="3657600"/>
                <a:ext cx="318977" cy="404037"/>
              </a:xfrm>
              <a:prstGeom prst="roundRect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QA" dirty="0"/>
              </a:p>
            </p:txBody>
          </p:sp>
          <p:pic>
            <p:nvPicPr>
              <p:cNvPr id="28" name="Picture 27" descr="A close up of a logo&#10;&#10;Description automatically generated">
                <a:extLst>
                  <a:ext uri="{FF2B5EF4-FFF2-40B4-BE49-F238E27FC236}">
                    <a16:creationId xmlns:a16="http://schemas.microsoft.com/office/drawing/2014/main" id="{431208AB-F510-134A-B03D-632D63C91BA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51979" y="121389"/>
                <a:ext cx="2667176" cy="5518295"/>
              </a:xfrm>
              <a:prstGeom prst="rect">
                <a:avLst/>
              </a:prstGeom>
            </p:spPr>
          </p:pic>
          <p:sp>
            <p:nvSpPr>
              <p:cNvPr id="54" name="Rounded Rectangle 53">
                <a:extLst>
                  <a:ext uri="{FF2B5EF4-FFF2-40B4-BE49-F238E27FC236}">
                    <a16:creationId xmlns:a16="http://schemas.microsoft.com/office/drawing/2014/main" id="{5F7225B8-9638-E44B-BB8A-50F0E328FEAF}"/>
                  </a:ext>
                </a:extLst>
              </p:cNvPr>
              <p:cNvSpPr/>
              <p:nvPr/>
            </p:nvSpPr>
            <p:spPr>
              <a:xfrm>
                <a:off x="2498651" y="3650105"/>
                <a:ext cx="420504" cy="457200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QA" dirty="0"/>
              </a:p>
            </p:txBody>
          </p:sp>
          <p:sp>
            <p:nvSpPr>
              <p:cNvPr id="55" name="Rounded Rectangle 54">
                <a:extLst>
                  <a:ext uri="{FF2B5EF4-FFF2-40B4-BE49-F238E27FC236}">
                    <a16:creationId xmlns:a16="http://schemas.microsoft.com/office/drawing/2014/main" id="{0965C7B8-BE91-7B45-A13E-44DBFFEAA7F4}"/>
                  </a:ext>
                </a:extLst>
              </p:cNvPr>
              <p:cNvSpPr/>
              <p:nvPr/>
            </p:nvSpPr>
            <p:spPr>
              <a:xfrm>
                <a:off x="2498651" y="4184910"/>
                <a:ext cx="420504" cy="551982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QA" dirty="0"/>
              </a:p>
            </p:txBody>
          </p:sp>
          <p:sp>
            <p:nvSpPr>
              <p:cNvPr id="56" name="Rounded Rectangle 55">
                <a:extLst>
                  <a:ext uri="{FF2B5EF4-FFF2-40B4-BE49-F238E27FC236}">
                    <a16:creationId xmlns:a16="http://schemas.microsoft.com/office/drawing/2014/main" id="{E203A98B-8634-9649-A56D-8AB5A4E76F60}"/>
                  </a:ext>
                </a:extLst>
              </p:cNvPr>
              <p:cNvSpPr/>
              <p:nvPr/>
            </p:nvSpPr>
            <p:spPr>
              <a:xfrm>
                <a:off x="2498651" y="5126505"/>
                <a:ext cx="420504" cy="442341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QA" dirty="0"/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D8ADECE9-7160-DA4B-9267-EB50C42A8AF1}"/>
                  </a:ext>
                </a:extLst>
              </p:cNvPr>
              <p:cNvSpPr txBox="1"/>
              <p:nvPr/>
            </p:nvSpPr>
            <p:spPr>
              <a:xfrm>
                <a:off x="2890030" y="3727226"/>
                <a:ext cx="4866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QA" sz="1200" b="1" dirty="0"/>
                  <a:t>ST45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139FAF08-977F-6044-892F-434C1D6B5857}"/>
                  </a:ext>
                </a:extLst>
              </p:cNvPr>
              <p:cNvSpPr txBox="1"/>
              <p:nvPr/>
            </p:nvSpPr>
            <p:spPr>
              <a:xfrm>
                <a:off x="2890030" y="4288365"/>
                <a:ext cx="5679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QA" sz="1200" b="1" dirty="0"/>
                  <a:t>ST307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E4C92F9E-575E-C943-A915-C2293EFC597D}"/>
                  </a:ext>
                </a:extLst>
              </p:cNvPr>
              <p:cNvSpPr txBox="1"/>
              <p:nvPr/>
            </p:nvSpPr>
            <p:spPr>
              <a:xfrm>
                <a:off x="2890030" y="5182788"/>
                <a:ext cx="5679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QA" sz="1200" b="1" dirty="0"/>
                  <a:t>ST268</a:t>
                </a:r>
              </a:p>
            </p:txBody>
          </p:sp>
        </p:grp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5022347E-D0FE-724D-8BF1-6AF6D01D48C3}"/>
                </a:ext>
              </a:extLst>
            </p:cNvPr>
            <p:cNvSpPr txBox="1"/>
            <p:nvPr/>
          </p:nvSpPr>
          <p:spPr>
            <a:xfrm>
              <a:off x="3288112" y="121389"/>
              <a:ext cx="3396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BB3E580D-1D8C-8A4D-8471-D264E1D40AFC}"/>
                </a:ext>
              </a:extLst>
            </p:cNvPr>
            <p:cNvSpPr txBox="1"/>
            <p:nvPr/>
          </p:nvSpPr>
          <p:spPr>
            <a:xfrm>
              <a:off x="264985" y="121389"/>
              <a:ext cx="14131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. S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037322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6</TotalTime>
  <Words>61</Words>
  <Application>Microsoft Office PowerPoint</Application>
  <PresentationFormat>Widescreen</PresentationFormat>
  <Paragraphs>2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hology Shared</dc:creator>
  <cp:lastModifiedBy>Andres Perez Lopez</cp:lastModifiedBy>
  <cp:revision>38</cp:revision>
  <dcterms:created xsi:type="dcterms:W3CDTF">2020-01-15T07:53:56Z</dcterms:created>
  <dcterms:modified xsi:type="dcterms:W3CDTF">2020-09-14T11:07:15Z</dcterms:modified>
</cp:coreProperties>
</file>